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864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tiff"/><Relationship Id="rId4" Type="http://schemas.openxmlformats.org/officeDocument/2006/relationships/image" Target="../media/image2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tiff"/><Relationship Id="rId4" Type="http://schemas.openxmlformats.org/officeDocument/2006/relationships/image" Target="../media/image33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8" name="TextBox 1037"/>
          <p:cNvSpPr txBox="1"/>
          <p:nvPr/>
        </p:nvSpPr>
        <p:spPr>
          <a:xfrm>
            <a:off x="2138186" y="3429040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3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651848" y="59313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3-1A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986266" y="44624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521-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588384" y="3406881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4-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E:\Documents and Settings\Administrator\Desktop\10521-2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0" y="329366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Documents and Settings\Administrator\Desktop\II-3-1A-1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313060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Documents and Settings\Administrator\Desktop\II-3-1 (1)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9" y="3674121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E:\Documents and Settings\Administrator\Desktop\II-4-2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0545" y="3683881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22374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95736" y="351204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29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60232" y="127665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7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57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88224" y="351204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9-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E:\Documents and Settings\Administrator\Desktop\2-57-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39" y="323298"/>
            <a:ext cx="4384801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E:\Documents and Settings\Administrator\Desktop\2-72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1565" y="323298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E:\Documents and Settings\Administrator\Desktop\II-29-1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" y="3714688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E:\Documents and Settings\Administrator\Desktop\II-9-3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1565" y="3724613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33149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195736" y="3512040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3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660232" y="127664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7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32112" y="11663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8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588224" y="3512040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1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 descr="E:\Documents and Settings\Administrator\Desktop\II-8-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" y="354716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E:\Documents and Settings\Administrator\Desktop\II-7-1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365561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E:\Documents and Settings\Administrator\Desktop\7365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" y="3712298"/>
            <a:ext cx="4384801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E:\Documents and Settings\Administrator\Desktop\4-11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0257" y="3726000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314482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95736" y="351204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7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60232" y="127665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1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88224" y="351204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8" name="Picture 2" descr="E:\Documents and Settings\Administrator\Desktop\4-12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56" y="461436"/>
            <a:ext cx="4357960" cy="31128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E:\Documents and Settings\Administrator\Desktop\4-6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4720" y="571302"/>
            <a:ext cx="4050334" cy="28930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E:\Documents and Settings\Administrator\Desktop\4-7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18" y="3880389"/>
            <a:ext cx="4071598" cy="29082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E:\Documents and Settings\Administrator\Desktop\4-8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975" y="3856137"/>
            <a:ext cx="3938513" cy="2813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" descr="E:\Documents and Settings\Administrator\Desktop\4-12.tif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32398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3" descr="E:\Documents and Settings\Administrator\Desktop\4-6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4382" y="365405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E:\Documents and Settings\Administrator\Desktop\4-7.tif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56" y="3724111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5" descr="E:\Documents and Settings\Administrator\Desktop\4-8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3558" y="3724111"/>
            <a:ext cx="4384801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507764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21-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372200" y="11663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21-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56656" y="3489864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52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14520" y="3520247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113-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 descr="E:\Documents and Settings\Administrator\Desktop\II-21-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37" y="349209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E:\Documents and Settings\Administrator\Desktop\II-21-6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7409" y="349209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E:\Documents and Settings\Administrator\Desktop\35524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36" y="3726000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E:\Documents and Settings\Administrator\Desktop\5113-2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080" y="3726000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38054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114-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68616" y="11663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30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60104" y="3489864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44-1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88224" y="3520247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44-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6" name="Picture 2" descr="E:\Documents and Settings\Administrator\Desktop\5114-3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57864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E:\Documents and Settings\Administrator\Desktop\II-30-5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4666" y="393630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E:\Documents and Settings\Administrator\Desktop\4844-12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3721391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E:\Documents and Settings\Administrator\Desktop\4844-8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118" y="3717032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207289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1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68616" y="11663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4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60104" y="3489864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6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88224" y="3520247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6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70" name="Picture 2" descr="E:\Documents and Settings\Administrator\Desktop\II-1-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357864"/>
            <a:ext cx="4384801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E:\Documents and Settings\Administrator\Desktop\7-49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595" y="357864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E:\Documents and Settings\Administrator\Desktop\7-64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741694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E:\Documents and Settings\Administrator\Desktop\7-65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8761" y="3741694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065058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32112" y="116632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-7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68616" y="11663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3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60104" y="3489864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4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88224" y="3520247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3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194" name="Picture 2" descr="E:\Documents and Settings\Administrator\Desktop\7-7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69008"/>
            <a:ext cx="4384801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E:\Documents and Settings\Administrator\Desktop\5038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5931" y="369008"/>
            <a:ext cx="4384799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E:\Documents and Settings\Administrator\Desktop\5043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20" y="3726000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E:\Documents and Settings\Administrator\Desktop\II-1-3.tif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5930" y="3707689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592031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39752" y="631721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5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668616" y="631720"/>
            <a:ext cx="855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-26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8972" y="4221088"/>
            <a:ext cx="8101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heterozygosity in wheat genome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e, heterozygosity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the ratio of heterozygous SNPs to all SNPs, which were counted in sliding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ndow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50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b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 step of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b and plotted along the chromosome.</a:t>
            </a:r>
            <a:endParaRPr lang="zh-CN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218" name="Picture 2" descr="E:\Documents and Settings\Administrator\Desktop\II-5-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036" y="919677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E:\Documents and Settings\Administrator\Desktop\II-26-1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3395" y="919677"/>
            <a:ext cx="4384800" cy="31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09333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77</Words>
  <Application>Microsoft Office PowerPoint</Application>
  <PresentationFormat>全屏显示(4:3)</PresentationFormat>
  <Paragraphs>35</Paragraphs>
  <Slides>9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38</cp:revision>
  <dcterms:created xsi:type="dcterms:W3CDTF">2017-08-24T09:31:32Z</dcterms:created>
  <dcterms:modified xsi:type="dcterms:W3CDTF">2017-09-14T08:49:02Z</dcterms:modified>
</cp:coreProperties>
</file>